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7" r:id="rId2"/>
    <p:sldId id="270" r:id="rId3"/>
    <p:sldId id="269" r:id="rId4"/>
    <p:sldId id="273" r:id="rId5"/>
    <p:sldId id="272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via" initials="L" lastIdx="5" clrIdx="0">
    <p:extLst>
      <p:ext uri="{19B8F6BF-5375-455C-9EA6-DF929625EA0E}">
        <p15:presenceInfo xmlns:p15="http://schemas.microsoft.com/office/powerpoint/2012/main" userId="Livia" providerId="None"/>
      </p:ext>
    </p:extLst>
  </p:cmAuthor>
  <p:cmAuthor id="2" name="Giulia Montagna" initials="GM" lastIdx="2" clrIdx="1">
    <p:extLst>
      <p:ext uri="{19B8F6BF-5375-455C-9EA6-DF929625EA0E}">
        <p15:presenceInfo xmlns:p15="http://schemas.microsoft.com/office/powerpoint/2012/main" userId="c47b7a4adb391757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861"/>
    <p:restoredTop sz="94663"/>
  </p:normalViewPr>
  <p:slideViewPr>
    <p:cSldViewPr snapToGrid="0" snapToObjects="1">
      <p:cViewPr varScale="1">
        <p:scale>
          <a:sx n="124" d="100"/>
          <a:sy n="124" d="100"/>
        </p:scale>
        <p:origin x="100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6BCF4-8540-1A4A-9516-39A5F8BCCD69}" type="datetimeFigureOut">
              <a:rPr lang="it-IT" smtClean="0"/>
              <a:t>15/05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59763-FCC2-B543-A793-9FD2C620DF4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861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6BCF4-8540-1A4A-9516-39A5F8BCCD69}" type="datetimeFigureOut">
              <a:rPr lang="it-IT" smtClean="0"/>
              <a:t>15/05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59763-FCC2-B543-A793-9FD2C620DF4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9521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6BCF4-8540-1A4A-9516-39A5F8BCCD69}" type="datetimeFigureOut">
              <a:rPr lang="it-IT" smtClean="0"/>
              <a:t>15/05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59763-FCC2-B543-A793-9FD2C620DF4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89942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6BCF4-8540-1A4A-9516-39A5F8BCCD69}" type="datetimeFigureOut">
              <a:rPr lang="it-IT" smtClean="0"/>
              <a:t>15/05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59763-FCC2-B543-A793-9FD2C620DF4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7297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6BCF4-8540-1A4A-9516-39A5F8BCCD69}" type="datetimeFigureOut">
              <a:rPr lang="it-IT" smtClean="0"/>
              <a:t>15/05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59763-FCC2-B543-A793-9FD2C620DF4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22645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6BCF4-8540-1A4A-9516-39A5F8BCCD69}" type="datetimeFigureOut">
              <a:rPr lang="it-IT" smtClean="0"/>
              <a:t>15/05/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59763-FCC2-B543-A793-9FD2C620DF4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65290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6BCF4-8540-1A4A-9516-39A5F8BCCD69}" type="datetimeFigureOut">
              <a:rPr lang="it-IT" smtClean="0"/>
              <a:t>15/05/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59763-FCC2-B543-A793-9FD2C620DF4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28498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6BCF4-8540-1A4A-9516-39A5F8BCCD69}" type="datetimeFigureOut">
              <a:rPr lang="it-IT" smtClean="0"/>
              <a:t>15/05/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59763-FCC2-B543-A793-9FD2C620DF4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83811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6BCF4-8540-1A4A-9516-39A5F8BCCD69}" type="datetimeFigureOut">
              <a:rPr lang="it-IT" smtClean="0"/>
              <a:t>15/05/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59763-FCC2-B543-A793-9FD2C620DF4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305778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6BCF4-8540-1A4A-9516-39A5F8BCCD69}" type="datetimeFigureOut">
              <a:rPr lang="it-IT" smtClean="0"/>
              <a:t>15/05/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59763-FCC2-B543-A793-9FD2C620DF4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12996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C6BCF4-8540-1A4A-9516-39A5F8BCCD69}" type="datetimeFigureOut">
              <a:rPr lang="it-IT" smtClean="0"/>
              <a:t>15/05/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59763-FCC2-B543-A793-9FD2C620DF4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09600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C6BCF4-8540-1A4A-9516-39A5F8BCCD69}" type="datetimeFigureOut">
              <a:rPr lang="it-IT" smtClean="0"/>
              <a:t>15/05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759763-FCC2-B543-A793-9FD2C620DF4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463432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A350031A-E045-4343-9270-03B512B57C6C}"/>
              </a:ext>
            </a:extLst>
          </p:cNvPr>
          <p:cNvSpPr/>
          <p:nvPr/>
        </p:nvSpPr>
        <p:spPr>
          <a:xfrm>
            <a:off x="778988" y="2109540"/>
            <a:ext cx="758602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 in vivo comparison study between strontium nanoparticles and rhBMP2 </a:t>
            </a:r>
            <a:endParaRPr lang="en-GB" sz="36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8FFCD3E5-6A14-9941-9E9B-B456B282D76B}"/>
              </a:ext>
            </a:extLst>
          </p:cNvPr>
          <p:cNvSpPr/>
          <p:nvPr/>
        </p:nvSpPr>
        <p:spPr>
          <a:xfrm>
            <a:off x="778988" y="3548131"/>
            <a:ext cx="758602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</a:t>
            </a:r>
            <a:endParaRPr lang="en-GB" sz="24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4109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F3072A45-B6F0-814B-B956-375A808B06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701719"/>
              </p:ext>
            </p:extLst>
          </p:nvPr>
        </p:nvGraphicFramePr>
        <p:xfrm>
          <a:off x="5715007" y="1462060"/>
          <a:ext cx="3144519" cy="2320290"/>
        </p:xfrm>
        <a:graphic>
          <a:graphicData uri="http://schemas.openxmlformats.org/drawingml/2006/table">
            <a:tbl>
              <a:tblPr firstRow="1"/>
              <a:tblGrid>
                <a:gridCol w="599307">
                  <a:extLst>
                    <a:ext uri="{9D8B030D-6E8A-4147-A177-3AD203B41FA5}">
                      <a16:colId xmlns:a16="http://schemas.microsoft.com/office/drawing/2014/main" val="1260689482"/>
                    </a:ext>
                  </a:extLst>
                </a:gridCol>
                <a:gridCol w="848404">
                  <a:extLst>
                    <a:ext uri="{9D8B030D-6E8A-4147-A177-3AD203B41FA5}">
                      <a16:colId xmlns:a16="http://schemas.microsoft.com/office/drawing/2014/main" val="2908338705"/>
                    </a:ext>
                  </a:extLst>
                </a:gridCol>
                <a:gridCol w="848404">
                  <a:extLst>
                    <a:ext uri="{9D8B030D-6E8A-4147-A177-3AD203B41FA5}">
                      <a16:colId xmlns:a16="http://schemas.microsoft.com/office/drawing/2014/main" val="2898921962"/>
                    </a:ext>
                  </a:extLst>
                </a:gridCol>
                <a:gridCol w="848404">
                  <a:extLst>
                    <a:ext uri="{9D8B030D-6E8A-4147-A177-3AD203B41FA5}">
                      <a16:colId xmlns:a16="http://schemas.microsoft.com/office/drawing/2014/main" val="1617570994"/>
                    </a:ext>
                  </a:extLst>
                </a:gridCol>
              </a:tblGrid>
              <a:tr h="179705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ime</a:t>
                      </a:r>
                      <a:r>
                        <a:rPr lang="en-US" sz="12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days)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7310" marT="27305" marB="2730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 b="1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HAn</a:t>
                      </a:r>
                      <a:endParaRPr lang="it-IT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SrHAn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50895513"/>
                  </a:ext>
                </a:extLst>
              </a:tr>
              <a:tr h="17970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 (mg/L)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 (mg/L)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r (mg/L)</a:t>
                      </a:r>
                      <a:endParaRPr lang="it-IT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3348804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7310" marT="27305" marB="2730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9593316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7310" marT="27305" marB="2730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0.5 ± 0.7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5.5 ± 2.1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9.5 ± 3.5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266656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7310" marT="27305" marB="2730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6.0 ± 1.4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8.0 ± 1.4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7.5 ± 3.5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534760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7310" marT="27305" marB="2730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8.5 ± 0.7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.5 ± 2.1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5.5 ± 2.1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62313754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7310" marT="27305" marB="2730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4.0 ± 1.4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3.0 ± 1.4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9.5 ± 2.1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52997118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7310" marT="27305" marB="2730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6.5 ± 0.7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.0 ± 0.0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8.0 ± 1.4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3778033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1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7310" marT="27305" marB="2730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2.5 ± 0.7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3.5 ± 0.7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3.0 ± 2.8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6856892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8</a:t>
                      </a:r>
                      <a:endParaRPr lang="it-IT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7310" marT="27305" marB="27305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3.0 ± 1.4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.5 ± 0.7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8.0 ± 1.4</a:t>
                      </a:r>
                      <a:endParaRPr lang="it-IT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7141492"/>
                  </a:ext>
                </a:extLst>
              </a:tr>
            </a:tbl>
          </a:graphicData>
        </a:graphic>
      </p:graphicFrame>
      <p:sp>
        <p:nvSpPr>
          <p:cNvPr id="8" name="Title 1">
            <a:extLst>
              <a:ext uri="{FF2B5EF4-FFF2-40B4-BE49-F238E27FC236}">
                <a16:creationId xmlns:a16="http://schemas.microsoft.com/office/drawing/2014/main" id="{039132DC-7030-EF48-ACBF-A83108611D42}"/>
              </a:ext>
            </a:extLst>
          </p:cNvPr>
          <p:cNvSpPr>
            <a:spLocks noGrp="1"/>
          </p:cNvSpPr>
          <p:nvPr/>
        </p:nvSpPr>
        <p:spPr>
          <a:xfrm>
            <a:off x="5414969" y="3991596"/>
            <a:ext cx="3444557" cy="101586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le S1: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ular representation of the data shown in Fig S3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Average concentration values and standard deviations of the calcium and strontium ions measured in the different sponges. </a:t>
            </a:r>
            <a:endParaRPr lang="it-IT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Title 1">
            <a:extLst>
              <a:ext uri="{FF2B5EF4-FFF2-40B4-BE49-F238E27FC236}">
                <a16:creationId xmlns:a16="http://schemas.microsoft.com/office/drawing/2014/main" id="{70D21F5E-47C5-1445-A6E7-5B7C4890D112}"/>
              </a:ext>
            </a:extLst>
          </p:cNvPr>
          <p:cNvSpPr txBox="1">
            <a:spLocks/>
          </p:cNvSpPr>
          <p:nvPr/>
        </p:nvSpPr>
        <p:spPr>
          <a:xfrm>
            <a:off x="284474" y="4122949"/>
            <a:ext cx="4897126" cy="1255728"/>
          </a:xfrm>
          <a:prstGeom prst="rect">
            <a:avLst/>
          </a:prstGeom>
          <a:noFill/>
        </p:spPr>
        <p:txBody>
          <a:bodyPr vert="horz" wrap="square" lIns="91440" tIns="45720" rIns="91440" bIns="45720" rtlCol="0" anchor="ctr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 defTabSz="457200"/>
            <a:r>
              <a:rPr lang="en" sz="1200" b="1" dirty="0"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g. S1: Quantification of calcium and strontium ions release from loaded treated sponge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CP-OES data representation of calcium and strontium ions release from sponges treated with an additional lyophilization step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A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SrHA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ion release was measured during the 28 days in aqueous solution. Ca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+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eased from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A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onge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Ca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Sr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+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eased from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SrHA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onge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3 samples were measure per each time point. </a:t>
            </a:r>
            <a:endParaRPr lang="en" sz="1200" dirty="0"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FAD761AF-E1A4-2E41-8A54-AF552287D25A}"/>
              </a:ext>
            </a:extLst>
          </p:cNvPr>
          <p:cNvGrpSpPr/>
          <p:nvPr/>
        </p:nvGrpSpPr>
        <p:grpSpPr>
          <a:xfrm>
            <a:off x="176754" y="894404"/>
            <a:ext cx="5238215" cy="3097192"/>
            <a:chOff x="176754" y="894404"/>
            <a:chExt cx="5238215" cy="309719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C1455D84-04FF-D047-8925-DDC67984A17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5226" y="894404"/>
              <a:ext cx="5219743" cy="3097192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8166724E-C490-4046-80FE-188F99640C92}"/>
                </a:ext>
              </a:extLst>
            </p:cNvPr>
            <p:cNvSpPr txBox="1"/>
            <p:nvPr/>
          </p:nvSpPr>
          <p:spPr>
            <a:xfrm rot="16200000">
              <a:off x="2506336" y="2493311"/>
              <a:ext cx="48888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mg/L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D3637B4-D46F-564C-A3A5-519F51820EC6}"/>
                </a:ext>
              </a:extLst>
            </p:cNvPr>
            <p:cNvSpPr txBox="1"/>
            <p:nvPr/>
          </p:nvSpPr>
          <p:spPr>
            <a:xfrm rot="16200000">
              <a:off x="40032" y="2489248"/>
              <a:ext cx="48888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mg/L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E07FD81-BF52-3549-86AA-BFED2E85AADE}"/>
                </a:ext>
              </a:extLst>
            </p:cNvPr>
            <p:cNvSpPr txBox="1"/>
            <p:nvPr/>
          </p:nvSpPr>
          <p:spPr>
            <a:xfrm>
              <a:off x="1252205" y="3776152"/>
              <a:ext cx="71820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Time (days)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1739511-7F85-A649-95B9-CABA478D88E7}"/>
                </a:ext>
              </a:extLst>
            </p:cNvPr>
            <p:cNvSpPr txBox="1"/>
            <p:nvPr/>
          </p:nvSpPr>
          <p:spPr>
            <a:xfrm>
              <a:off x="3729032" y="3776152"/>
              <a:ext cx="71820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/>
                <a:t>Time (days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743941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FA4F0CC9-9A05-194A-A467-00D480546DCD}"/>
              </a:ext>
            </a:extLst>
          </p:cNvPr>
          <p:cNvSpPr txBox="1">
            <a:spLocks/>
          </p:cNvSpPr>
          <p:nvPr/>
        </p:nvSpPr>
        <p:spPr>
          <a:xfrm>
            <a:off x="6158390" y="861017"/>
            <a:ext cx="2865689" cy="513596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r>
              <a:rPr lang="e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% confidence intervals of ICP-OES data: Tukey’s honestly significant difference. </a:t>
            </a:r>
            <a:r>
              <a:rPr lang="e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CP-OES data collected either from the untreated samples (</a:t>
            </a:r>
            <a:r>
              <a:rPr lang="e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rts A, B and C</a:t>
            </a:r>
            <a:r>
              <a:rPr lang="e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from the treated samples (</a:t>
            </a:r>
            <a:r>
              <a:rPr lang="e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rts D, E and F</a:t>
            </a:r>
            <a:r>
              <a:rPr lang="e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re analyzed by one-way ANOVA, corrected with Tukey’s test and confidence intervals were plotted in the shown charts. 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3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mples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zed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me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int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CasellaDiTesto 1"/>
          <p:cNvSpPr txBox="1"/>
          <p:nvPr/>
        </p:nvSpPr>
        <p:spPr>
          <a:xfrm>
            <a:off x="2737671" y="-15240"/>
            <a:ext cx="162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UNTREATED</a:t>
            </a:r>
          </a:p>
        </p:txBody>
      </p:sp>
      <p:sp>
        <p:nvSpPr>
          <p:cNvPr id="5" name="CasellaDiTesto 4"/>
          <p:cNvSpPr txBox="1"/>
          <p:nvPr/>
        </p:nvSpPr>
        <p:spPr>
          <a:xfrm>
            <a:off x="2927127" y="3313584"/>
            <a:ext cx="14261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TREATED</a:t>
            </a:r>
          </a:p>
        </p:txBody>
      </p:sp>
      <p:sp>
        <p:nvSpPr>
          <p:cNvPr id="7" name="Parentesi graffa aperta 6"/>
          <p:cNvSpPr/>
          <p:nvPr/>
        </p:nvSpPr>
        <p:spPr>
          <a:xfrm rot="5400000">
            <a:off x="3289152" y="-2158743"/>
            <a:ext cx="166788" cy="5135883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Parentesi graffa aperta 7"/>
          <p:cNvSpPr/>
          <p:nvPr/>
        </p:nvSpPr>
        <p:spPr>
          <a:xfrm rot="5400000">
            <a:off x="3289153" y="1137409"/>
            <a:ext cx="166788" cy="5135883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831B2639-CD9B-AA4D-96D9-DB8C20686F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4059" y="371251"/>
            <a:ext cx="4894177" cy="2942333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DFD3F4B-A2E2-F842-A144-D78F5502169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3631" y="3705350"/>
            <a:ext cx="5015031" cy="29453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11278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7CF1D9-3BE4-1948-80CA-DD66A0866498}"/>
              </a:ext>
            </a:extLst>
          </p:cNvPr>
          <p:cNvSpPr txBox="1">
            <a:spLocks/>
          </p:cNvSpPr>
          <p:nvPr/>
        </p:nvSpPr>
        <p:spPr>
          <a:xfrm>
            <a:off x="1499017" y="5358028"/>
            <a:ext cx="6145966" cy="900246"/>
          </a:xfrm>
          <a:prstGeom prst="rect">
            <a:avLst/>
          </a:prstGeom>
          <a:noFill/>
        </p:spPr>
        <p:txBody>
          <a:bodyPr vert="horz" wrap="square" lIns="68580" tIns="34290" rIns="68580" bIns="34290" rtlCol="0" anchor="ctr">
            <a:sp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3: IR evaluation of sponge-nanoparticles interaction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T-IR spectra of treated and loaded sponges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A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SrHA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t 28 day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). In the panel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-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FT-IR spectrum of untreated and unloaded sponge was reported (CTRL). Spectra were divided in two sections: wavenumber range 4000-3000 cm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reported in panel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 C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while wavenumber range 2000-650 cm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shown in panel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, D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0A799BA-7BA2-7147-974A-AE186A8EB646}"/>
              </a:ext>
            </a:extLst>
          </p:cNvPr>
          <p:cNvSpPr txBox="1"/>
          <p:nvPr/>
        </p:nvSpPr>
        <p:spPr>
          <a:xfrm rot="16200000">
            <a:off x="78600" y="1225974"/>
            <a:ext cx="709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6287A07-C63E-5F48-8287-E87C618DC0D8}"/>
              </a:ext>
            </a:extLst>
          </p:cNvPr>
          <p:cNvSpPr txBox="1"/>
          <p:nvPr/>
        </p:nvSpPr>
        <p:spPr>
          <a:xfrm rot="16200000">
            <a:off x="107618" y="2441664"/>
            <a:ext cx="709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HAn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AA8AF10-421D-254D-A444-5EEE0D8BA467}"/>
              </a:ext>
            </a:extLst>
          </p:cNvPr>
          <p:cNvSpPr txBox="1"/>
          <p:nvPr/>
        </p:nvSpPr>
        <p:spPr>
          <a:xfrm rot="16200000">
            <a:off x="80621" y="3521874"/>
            <a:ext cx="76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SrHAn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4A1D939-39E7-5A44-A19A-874E93C071DF}"/>
              </a:ext>
            </a:extLst>
          </p:cNvPr>
          <p:cNvSpPr txBox="1"/>
          <p:nvPr/>
        </p:nvSpPr>
        <p:spPr>
          <a:xfrm>
            <a:off x="5133782" y="2764289"/>
            <a:ext cx="4186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465482E-438E-0A45-B310-2B74093ED56D}"/>
              </a:ext>
            </a:extLst>
          </p:cNvPr>
          <p:cNvSpPr txBox="1"/>
          <p:nvPr/>
        </p:nvSpPr>
        <p:spPr>
          <a:xfrm>
            <a:off x="2189147" y="4332684"/>
            <a:ext cx="15502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Wavenumber (cm</a:t>
            </a:r>
            <a:r>
              <a:rPr lang="en-US" sz="1200" b="1" baseline="30000" dirty="0"/>
              <a:t>-1</a:t>
            </a:r>
            <a:r>
              <a:rPr lang="en-US" sz="1200" b="1" dirty="0"/>
              <a:t>)</a:t>
            </a:r>
            <a:endParaRPr lang="en-US" sz="1200" b="1" baseline="300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F654D52-CE66-EC4B-B6E4-E9934B1428BA}"/>
              </a:ext>
            </a:extLst>
          </p:cNvPr>
          <p:cNvSpPr txBox="1"/>
          <p:nvPr/>
        </p:nvSpPr>
        <p:spPr>
          <a:xfrm>
            <a:off x="6273994" y="4358697"/>
            <a:ext cx="15275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Wavenumber (cm</a:t>
            </a:r>
            <a:r>
              <a:rPr lang="en-US" sz="1200" b="1" baseline="30000" dirty="0"/>
              <a:t>-1</a:t>
            </a:r>
            <a:r>
              <a:rPr lang="en-US" sz="1200" b="1" dirty="0"/>
              <a:t>)</a:t>
            </a:r>
            <a:endParaRPr lang="en-US" sz="1200" b="1" baseline="300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F260560-5859-3645-9AE6-D400E256ECA3}"/>
              </a:ext>
            </a:extLst>
          </p:cNvPr>
          <p:cNvSpPr txBox="1"/>
          <p:nvPr/>
        </p:nvSpPr>
        <p:spPr>
          <a:xfrm rot="16200000">
            <a:off x="-83849" y="2426274"/>
            <a:ext cx="15877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% Transmittance</a:t>
            </a:r>
          </a:p>
        </p:txBody>
      </p:sp>
      <p:pic>
        <p:nvPicPr>
          <p:cNvPr id="11" name="Picture 10" descr="A picture containing black, apple, sitting, dark&#10;&#10;Description automatically generated">
            <a:extLst>
              <a:ext uri="{FF2B5EF4-FFF2-40B4-BE49-F238E27FC236}">
                <a16:creationId xmlns:a16="http://schemas.microsoft.com/office/drawing/2014/main" id="{0C62C0C8-58B4-C149-BB9E-2FE7730BA3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48164" y="679153"/>
            <a:ext cx="4379248" cy="3792031"/>
          </a:xfrm>
          <a:prstGeom prst="rect">
            <a:avLst/>
          </a:prstGeom>
        </p:spPr>
      </p:pic>
      <p:pic>
        <p:nvPicPr>
          <p:cNvPr id="13" name="Picture 12" descr="A picture containing black, sitting, dark, photo&#10;&#10;Description automatically generated">
            <a:extLst>
              <a:ext uri="{FF2B5EF4-FFF2-40B4-BE49-F238E27FC236}">
                <a16:creationId xmlns:a16="http://schemas.microsoft.com/office/drawing/2014/main" id="{DB149985-F13C-7C4F-A5E3-EDF00A2E5D8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7534" y="668759"/>
            <a:ext cx="4353449" cy="3792031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7BCFAFDE-FF7F-404B-9D63-31D696065BC4}"/>
              </a:ext>
            </a:extLst>
          </p:cNvPr>
          <p:cNvSpPr txBox="1"/>
          <p:nvPr/>
        </p:nvSpPr>
        <p:spPr>
          <a:xfrm>
            <a:off x="5133782" y="1593217"/>
            <a:ext cx="4186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BB72BB2-63AB-3545-AAE9-EFA1F9331607}"/>
              </a:ext>
            </a:extLst>
          </p:cNvPr>
          <p:cNvSpPr txBox="1"/>
          <p:nvPr/>
        </p:nvSpPr>
        <p:spPr>
          <a:xfrm>
            <a:off x="1070611" y="2746004"/>
            <a:ext cx="4186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8A149A2-AB99-0041-A340-9F34E1C5324B}"/>
              </a:ext>
            </a:extLst>
          </p:cNvPr>
          <p:cNvSpPr txBox="1"/>
          <p:nvPr/>
        </p:nvSpPr>
        <p:spPr>
          <a:xfrm>
            <a:off x="1080771" y="1570218"/>
            <a:ext cx="4186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CA77AC6-0DE1-0849-BE79-7ACADF911CB4}"/>
              </a:ext>
            </a:extLst>
          </p:cNvPr>
          <p:cNvSpPr txBox="1"/>
          <p:nvPr/>
        </p:nvSpPr>
        <p:spPr>
          <a:xfrm>
            <a:off x="1060451" y="3901470"/>
            <a:ext cx="4186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A42C819-BC2C-254C-9A51-0FAFFBE8FE82}"/>
              </a:ext>
            </a:extLst>
          </p:cNvPr>
          <p:cNvSpPr txBox="1"/>
          <p:nvPr/>
        </p:nvSpPr>
        <p:spPr>
          <a:xfrm>
            <a:off x="5134424" y="3913436"/>
            <a:ext cx="4186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7267140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34C412E-542E-224F-AE03-97B1A1668C18}"/>
              </a:ext>
            </a:extLst>
          </p:cNvPr>
          <p:cNvSpPr txBox="1"/>
          <p:nvPr/>
        </p:nvSpPr>
        <p:spPr>
          <a:xfrm>
            <a:off x="906174" y="4811843"/>
            <a:ext cx="7331649" cy="899410"/>
          </a:xfrm>
          <a:prstGeom prst="rect">
            <a:avLst/>
          </a:prstGeom>
        </p:spPr>
        <p:txBody>
          <a:bodyPr vert="horz" lIns="63305" tIns="31652" rIns="63305" bIns="31652" rtlCol="0" anchor="ctr">
            <a:noAutofit/>
          </a:bodyPr>
          <a:lstStyle>
            <a:lvl1pPr defTabSz="685800">
              <a:lnSpc>
                <a:spcPct val="90000"/>
              </a:lnSpc>
              <a:spcBef>
                <a:spcPct val="0"/>
              </a:spcBef>
              <a:buNone/>
              <a:defRPr sz="1200" b="1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defRPr>
            </a:lvl1pPr>
          </a:lstStyle>
          <a:p>
            <a:pPr algn="just"/>
            <a:r>
              <a:rPr lang="en-US" sz="831" dirty="0"/>
              <a:t> </a:t>
            </a:r>
            <a:r>
              <a:rPr lang="en-US" dirty="0">
                <a:ea typeface="+mn-ea"/>
              </a:rPr>
              <a:t>Fig S4: SEM analysis of treated sponges. </a:t>
            </a:r>
            <a:r>
              <a:rPr lang="en-US" b="0" dirty="0">
                <a:ea typeface="+mn-ea"/>
              </a:rPr>
              <a:t>The microscopic structure (150x and 350x) of the </a:t>
            </a:r>
            <a:r>
              <a:rPr lang="en-US" b="0" dirty="0" err="1">
                <a:ea typeface="+mn-ea"/>
              </a:rPr>
              <a:t>sCTRL</a:t>
            </a:r>
            <a:r>
              <a:rPr lang="en-US" b="0" dirty="0">
                <a:ea typeface="+mn-ea"/>
              </a:rPr>
              <a:t> (unloaded sponges), </a:t>
            </a:r>
            <a:r>
              <a:rPr lang="en-US" b="0" dirty="0" err="1">
                <a:ea typeface="+mn-ea"/>
              </a:rPr>
              <a:t>sHAn</a:t>
            </a:r>
            <a:r>
              <a:rPr lang="en-US" b="0" dirty="0">
                <a:ea typeface="+mn-ea"/>
              </a:rPr>
              <a:t> and </a:t>
            </a:r>
            <a:r>
              <a:rPr lang="en-US" b="0" dirty="0" err="1">
                <a:ea typeface="+mn-ea"/>
              </a:rPr>
              <a:t>sSrHAn</a:t>
            </a:r>
            <a:r>
              <a:rPr lang="en-US" b="0" dirty="0">
                <a:ea typeface="+mn-ea"/>
              </a:rPr>
              <a:t> (loaded sponges) samples following the lyophilization treatment is shown. Pictures represent samples at T0 (</a:t>
            </a:r>
            <a:r>
              <a:rPr lang="en-US" dirty="0">
                <a:ea typeface="+mn-ea"/>
              </a:rPr>
              <a:t>A, B and C</a:t>
            </a:r>
            <a:r>
              <a:rPr lang="en-US" b="0" dirty="0">
                <a:ea typeface="+mn-ea"/>
              </a:rPr>
              <a:t>) and after 28 days (</a:t>
            </a:r>
            <a:r>
              <a:rPr lang="en-US" dirty="0">
                <a:ea typeface="+mn-ea"/>
              </a:rPr>
              <a:t>panels D, E and F</a:t>
            </a:r>
            <a:r>
              <a:rPr lang="en-US" b="0" dirty="0">
                <a:ea typeface="+mn-ea"/>
              </a:rPr>
              <a:t>) of permanence in aqueous solution, in a control</a:t>
            </a:r>
            <a:r>
              <a:rPr lang="it-IT" b="0" dirty="0">
                <a:ea typeface="+mn-ea"/>
              </a:rPr>
              <a:t>l</a:t>
            </a:r>
            <a:r>
              <a:rPr lang="en-US" b="0" dirty="0">
                <a:ea typeface="+mn-ea"/>
              </a:rPr>
              <a:t>ed and humidified atmosphere (37°C, with 5% of CO2). </a:t>
            </a:r>
            <a:endParaRPr lang="it-IT" b="0" dirty="0">
              <a:ea typeface="+mn-ea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CAE741A-3D93-B248-ACE7-A81A94F770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4383" y="408562"/>
            <a:ext cx="7895229" cy="41503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75052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20</TotalTime>
  <Words>512</Words>
  <Application>Microsoft Macintosh PowerPoint</Application>
  <PresentationFormat>On-screen Show (4:3)</PresentationFormat>
  <Paragraphs>6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ulia Montagna</dc:creator>
  <cp:lastModifiedBy>Giulia Montagna</cp:lastModifiedBy>
  <cp:revision>103</cp:revision>
  <dcterms:created xsi:type="dcterms:W3CDTF">2019-04-11T10:52:30Z</dcterms:created>
  <dcterms:modified xsi:type="dcterms:W3CDTF">2020-05-15T14:13:36Z</dcterms:modified>
</cp:coreProperties>
</file>